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582F2-1869-4D12-9D16-5DA283BE77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D1430-AE41-41F5-A869-ED8D2A5419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8C501-6A77-424E-8074-ED6D9C8497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C5563-9A5B-40F8-8C3C-3B2E86FFFE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DF3B0-72FA-449F-AA8A-3D8DE81E7A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A2F17-8851-4465-9051-E7F739063C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5F5AA-DC49-440C-84A6-FE7E1D2133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295CD-BE06-4C73-9B2C-D770CD5882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F9A6A-A2C4-431B-B850-9DE0BB993A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C2471-BB31-44B1-A887-B2F34BD820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B97F9-51AB-4694-871F-80972B5F1F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B9A39-C0D6-4127-A9C3-B313C609C9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55B017-B2C6-42B7-8352-688C9A01D37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114640" y="2359080"/>
            <a:ext cx="4529160" cy="2589120"/>
          </a:xfrm>
          <a:prstGeom prst="rect">
            <a:avLst/>
          </a:prstGeom>
          <a:ln w="0">
            <a:noFill/>
          </a:ln>
        </p:spPr>
      </p:pic>
      <p:sp>
        <p:nvSpPr>
          <p:cNvPr id="42" name="TextBox 3"/>
          <p:cNvSpPr/>
          <p:nvPr/>
        </p:nvSpPr>
        <p:spPr>
          <a:xfrm>
            <a:off x="2679120" y="49309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3689640" y="493092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4748040" y="4930920"/>
            <a:ext cx="69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5824800" y="4930920"/>
            <a:ext cx="82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30 m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1831320" y="37879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1714680" y="328788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1714680" y="277488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1714680" y="2287440"/>
            <a:ext cx="41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3242520" y="1359000"/>
            <a:ext cx="105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wild-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5264280" y="1363680"/>
            <a:ext cx="74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Calibri"/>
              </a:rPr>
              <a:t>Irs2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-/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3"/>
          <p:cNvSpPr/>
          <p:nvPr/>
        </p:nvSpPr>
        <p:spPr>
          <a:xfrm>
            <a:off x="2658960" y="1697040"/>
            <a:ext cx="2000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4"/>
          <p:cNvSpPr/>
          <p:nvPr/>
        </p:nvSpPr>
        <p:spPr>
          <a:xfrm>
            <a:off x="4873680" y="1684440"/>
            <a:ext cx="1500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5"/>
          <p:cNvSpPr/>
          <p:nvPr/>
        </p:nvSpPr>
        <p:spPr>
          <a:xfrm rot="18101400">
            <a:off x="292608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5.5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6"/>
          <p:cNvSpPr/>
          <p:nvPr/>
        </p:nvSpPr>
        <p:spPr>
          <a:xfrm rot="18101400">
            <a:off x="349776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5.7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7"/>
          <p:cNvSpPr/>
          <p:nvPr/>
        </p:nvSpPr>
        <p:spPr>
          <a:xfrm rot="18101400">
            <a:off x="406908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6.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 rot="18101400">
            <a:off x="489960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5.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 rot="18101400">
            <a:off x="539964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5.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 rot="18101400">
            <a:off x="5899680" y="190980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5.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124560" y="5286240"/>
            <a:ext cx="86601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 Figure S2. Reduced kidney size is evident in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rs2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/- kidneys compared to wild-type at 12 days of age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idneys wer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moved from mice prior to perfusion fixation and stored at -80 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in RNAlater. Kidneys from wild-type and Irs2-/- were placed 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glass slide and photographed. Kidney:body weight ratios for each mouse are shown above each kidney. Size scale in mm is show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9T11:40:13Z</dcterms:created>
  <dc:creator>QUB</dc:creator>
  <dc:description/>
  <dc:language>en-US</dc:language>
  <cp:lastModifiedBy>QUB</cp:lastModifiedBy>
  <dcterms:modified xsi:type="dcterms:W3CDTF">2010-06-27T11:30:14Z</dcterms:modified>
  <cp:revision>4</cp:revision>
  <dc:subject/>
  <dc:title>Slide 1</dc:title>
</cp:coreProperties>
</file>